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9F7C4C-8DE9-4C10-887B-C335663E4D9A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861C10-98BE-4695-B60F-4382B88B42A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785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60025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7388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74635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8498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2205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0351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2080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24554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80697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938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40DAB-6968-458A-B66E-142303D93C3D}" type="datetimeFigureOut">
              <a:rPr lang="en-IN" smtClean="0"/>
              <a:t>29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6DD8C-31CA-4F89-9ED0-921EC6337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6064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235389" y="3164851"/>
            <a:ext cx="6678489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1: 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equence of DNA probes used for the EMSA experiment.</a:t>
            </a:r>
            <a:r>
              <a:rPr lang="en-US" sz="14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he prob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equence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were adopted from the 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Rom et al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2006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and their consensus sequence were modified. For probe ARBS-1 to ARBS-4, consensus sequence were adopted from 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Rom et al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2006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whil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or ARBS-5 to ARBS-8 adopted from </a:t>
            </a:r>
            <a:r>
              <a:rPr lang="en-US" sz="1400" dirty="0" err="1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Ricardi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 et al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400" dirty="0" smtClean="0">
                <a:solidFill>
                  <a:srgbClr val="000099"/>
                </a:solidFill>
                <a:latin typeface="Times New Roman" pitchFamily="18" charset="0"/>
                <a:cs typeface="Times New Roman" pitchFamily="18" charset="0"/>
              </a:rPr>
              <a:t>2014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235390" y="764704"/>
            <a:ext cx="6678488" cy="2308324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1: 5’-AAGCTTATTCCAC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CC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2: 5’-GAAGCTTATTCCAC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CG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3: 5’-GAAGCTTATTCCAC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C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4: 5’-GAAGCTTATTCCAC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G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5: 5’-GAAGCTTATTCCA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CCCA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6: 5’-GAAGCTTATTCCA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CCAA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7: 5’-GAAGCTTATTCCA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CCCAT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</a:p>
          <a:p>
            <a:pPr lvl="0"/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RBS-8: 5’-GAAGCTTATTCCA</a:t>
            </a:r>
            <a:r>
              <a:rPr lang="en-IN" b="1" dirty="0">
                <a:solidFill>
                  <a:srgbClr val="000099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CCAT</a:t>
            </a:r>
            <a:r>
              <a:rPr lang="en-IN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CCACTAGTTCT</a:t>
            </a:r>
            <a:endParaRPr lang="en-IN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6438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06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1</cp:revision>
  <dcterms:created xsi:type="dcterms:W3CDTF">2014-08-21T02:54:53Z</dcterms:created>
  <dcterms:modified xsi:type="dcterms:W3CDTF">2014-08-29T12:19:12Z</dcterms:modified>
</cp:coreProperties>
</file>